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6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23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3114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2616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5380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9901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654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2440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0910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711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551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177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936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89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286B9-0FA1-40EB-B5FF-CEC0B612C0BB}" type="datetimeFigureOut">
              <a:rPr kumimoji="1" lang="ja-JP" altLang="en-US" smtClean="0"/>
              <a:t>2021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E38DB-A8E9-460F-B939-228A2AB907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8387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1CD80BD-F5EE-4E83-ADFE-E94E423F85A6}"/>
              </a:ext>
            </a:extLst>
          </p:cNvPr>
          <p:cNvSpPr txBox="1"/>
          <p:nvPr/>
        </p:nvSpPr>
        <p:spPr>
          <a:xfrm>
            <a:off x="1147513" y="1081595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C755082-AC77-43D9-94D3-9B36AADB540E}"/>
              </a:ext>
            </a:extLst>
          </p:cNvPr>
          <p:cNvSpPr txBox="1"/>
          <p:nvPr/>
        </p:nvSpPr>
        <p:spPr>
          <a:xfrm>
            <a:off x="2470969" y="1081595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tandard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C4E9BE8-E4C5-4B71-B528-283E1E303037}"/>
              </a:ext>
            </a:extLst>
          </p:cNvPr>
          <p:cNvSpPr txBox="1"/>
          <p:nvPr/>
        </p:nvSpPr>
        <p:spPr>
          <a:xfrm>
            <a:off x="0" y="340881"/>
            <a:ext cx="6857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: Chromatograms of standard compounds of DNA adduct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A925E5A-D7B5-452C-AD4A-7665B67D1FA4}"/>
              </a:ext>
            </a:extLst>
          </p:cNvPr>
          <p:cNvSpPr txBox="1"/>
          <p:nvPr/>
        </p:nvSpPr>
        <p:spPr>
          <a:xfrm>
            <a:off x="4243627" y="1064978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2EEA8804-6832-4D1A-B642-51A9C389C51A}"/>
              </a:ext>
            </a:extLst>
          </p:cNvPr>
          <p:cNvSpPr txBox="1"/>
          <p:nvPr/>
        </p:nvSpPr>
        <p:spPr>
          <a:xfrm>
            <a:off x="5574552" y="1064978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tandard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40B5F9F-9F40-40BF-91D6-49502F6475AD}"/>
              </a:ext>
            </a:extLst>
          </p:cNvPr>
          <p:cNvSpPr txBox="1"/>
          <p:nvPr/>
        </p:nvSpPr>
        <p:spPr>
          <a:xfrm>
            <a:off x="529971" y="300315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D72FEA4-4AB6-465F-AD13-6875128825FC}"/>
              </a:ext>
            </a:extLst>
          </p:cNvPr>
          <p:cNvSpPr txBox="1"/>
          <p:nvPr/>
        </p:nvSpPr>
        <p:spPr>
          <a:xfrm>
            <a:off x="537987" y="486834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A548985-A494-42F1-873F-59F0D2216555}"/>
              </a:ext>
            </a:extLst>
          </p:cNvPr>
          <p:cNvSpPr txBox="1"/>
          <p:nvPr/>
        </p:nvSpPr>
        <p:spPr>
          <a:xfrm>
            <a:off x="537987" y="67464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7A8E2A5-7F0C-4023-B7AF-79254AB04194}"/>
              </a:ext>
            </a:extLst>
          </p:cNvPr>
          <p:cNvSpPr txBox="1"/>
          <p:nvPr/>
        </p:nvSpPr>
        <p:spPr>
          <a:xfrm>
            <a:off x="3613207" y="82998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E70F5D90-3464-44F6-8221-0F190002EF00}"/>
              </a:ext>
            </a:extLst>
          </p:cNvPr>
          <p:cNvSpPr txBox="1"/>
          <p:nvPr/>
        </p:nvSpPr>
        <p:spPr>
          <a:xfrm>
            <a:off x="3654885" y="3003152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A7E2031-47A3-47AA-9C24-0577E126F2C1}"/>
              </a:ext>
            </a:extLst>
          </p:cNvPr>
          <p:cNvSpPr txBox="1"/>
          <p:nvPr/>
        </p:nvSpPr>
        <p:spPr>
          <a:xfrm>
            <a:off x="3613207" y="486834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F042479C-E32F-46EC-85AC-76BC45A6F2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9971" y="3261093"/>
            <a:ext cx="1440000" cy="1631768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ADF9825C-DC37-4D7C-AE9F-944AAA547E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86511" y="3261093"/>
            <a:ext cx="1440000" cy="1628281"/>
          </a:xfrm>
          <a:prstGeom prst="rect">
            <a:avLst/>
          </a:prstGeom>
        </p:spPr>
      </p:pic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C018E65F-A3E7-44EE-AC7A-783D4145E3B0}"/>
              </a:ext>
            </a:extLst>
          </p:cNvPr>
          <p:cNvSpPr txBox="1"/>
          <p:nvPr/>
        </p:nvSpPr>
        <p:spPr>
          <a:xfrm>
            <a:off x="529971" y="86076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図 49">
            <a:extLst>
              <a:ext uri="{FF2B5EF4-FFF2-40B4-BE49-F238E27FC236}">
                <a16:creationId xmlns:a16="http://schemas.microsoft.com/office/drawing/2014/main" id="{5DD9BFB1-41F6-4F84-BA15-3AD4715AB8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9971" y="5116618"/>
            <a:ext cx="1440000" cy="1631768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32AD24D9-3783-4C09-88C5-6DEAFA63092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86511" y="5116618"/>
            <a:ext cx="1440000" cy="1628281"/>
          </a:xfrm>
          <a:prstGeom prst="rect">
            <a:avLst/>
          </a:prstGeom>
        </p:spPr>
      </p:pic>
      <p:pic>
        <p:nvPicPr>
          <p:cNvPr id="54" name="図 53">
            <a:extLst>
              <a:ext uri="{FF2B5EF4-FFF2-40B4-BE49-F238E27FC236}">
                <a16:creationId xmlns:a16="http://schemas.microsoft.com/office/drawing/2014/main" id="{C1FFBF51-C52D-4808-AEB2-95FD8AB0B5E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89000" y="1274021"/>
            <a:ext cx="1440000" cy="1628281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6FB27305-3953-4E9B-BEA4-5174FD026F2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9971" y="1274021"/>
            <a:ext cx="1440000" cy="1631768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E85AE0CA-E80E-4530-8D77-F70015095C4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9971" y="7029680"/>
            <a:ext cx="1440000" cy="1631768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FD126717-85E4-4546-8895-E009CA5F910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69971" y="7029680"/>
            <a:ext cx="1440000" cy="1628281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1D2AA5BD-9300-409F-97CF-8473344B106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45114" y="1274021"/>
            <a:ext cx="1440000" cy="1628281"/>
          </a:xfrm>
          <a:prstGeom prst="rect">
            <a:avLst/>
          </a:prstGeom>
        </p:spPr>
      </p:pic>
      <p:pic>
        <p:nvPicPr>
          <p:cNvPr id="64" name="図 63">
            <a:extLst>
              <a:ext uri="{FF2B5EF4-FFF2-40B4-BE49-F238E27FC236}">
                <a16:creationId xmlns:a16="http://schemas.microsoft.com/office/drawing/2014/main" id="{46256A06-3B73-4E3B-897B-B38CC3EA6E9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72586" y="1274021"/>
            <a:ext cx="1440000" cy="1631768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13A047A5-A13B-4FE0-B13D-4F27F48C178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672586" y="5116618"/>
            <a:ext cx="1440000" cy="1631768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D5492437-7C95-4ABC-ACA9-08208A0F707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145114" y="5116618"/>
            <a:ext cx="1440000" cy="1628281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8044668F-E563-4C2D-B908-88B773FDE55D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145114" y="3261093"/>
            <a:ext cx="1440000" cy="1656355"/>
          </a:xfrm>
          <a:prstGeom prst="rect">
            <a:avLst/>
          </a:prstGeom>
        </p:spPr>
      </p:pic>
      <p:pic>
        <p:nvPicPr>
          <p:cNvPr id="72" name="図 71">
            <a:extLst>
              <a:ext uri="{FF2B5EF4-FFF2-40B4-BE49-F238E27FC236}">
                <a16:creationId xmlns:a16="http://schemas.microsoft.com/office/drawing/2014/main" id="{91DE8762-08C0-4782-9623-02627E460B0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688850" y="3261093"/>
            <a:ext cx="1440000" cy="165582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4B24F2E-4273-4DA3-B93D-6B9CB23685C7}"/>
              </a:ext>
            </a:extLst>
          </p:cNvPr>
          <p:cNvSpPr txBox="1"/>
          <p:nvPr/>
        </p:nvSpPr>
        <p:spPr>
          <a:xfrm>
            <a:off x="1553417" y="860760"/>
            <a:ext cx="974947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5-methyl-dC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161F964-3C3B-451F-9D52-E86E8D5FC510}"/>
              </a:ext>
            </a:extLst>
          </p:cNvPr>
          <p:cNvSpPr txBox="1"/>
          <p:nvPr/>
        </p:nvSpPr>
        <p:spPr>
          <a:xfrm>
            <a:off x="1329798" y="4868349"/>
            <a:ext cx="1422184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5-hydroxymethyl-dC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8033D53-0D21-435E-BB9D-CA330CB447BF}"/>
              </a:ext>
            </a:extLst>
          </p:cNvPr>
          <p:cNvSpPr txBox="1"/>
          <p:nvPr/>
        </p:nvSpPr>
        <p:spPr>
          <a:xfrm>
            <a:off x="1557425" y="6746479"/>
            <a:ext cx="966931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6-methyl-d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5C5BCB0-DC5C-413E-930D-EDEEB6191073}"/>
              </a:ext>
            </a:extLst>
          </p:cNvPr>
          <p:cNvSpPr txBox="1"/>
          <p:nvPr/>
        </p:nvSpPr>
        <p:spPr>
          <a:xfrm>
            <a:off x="4679736" y="860760"/>
            <a:ext cx="785793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Etheno-d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05B0CD63-6F4A-46B0-A31F-B697B338ADF8}"/>
              </a:ext>
            </a:extLst>
          </p:cNvPr>
          <p:cNvSpPr txBox="1"/>
          <p:nvPr/>
        </p:nvSpPr>
        <p:spPr>
          <a:xfrm>
            <a:off x="4365547" y="3003152"/>
            <a:ext cx="1414170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6-hydroxymethyl-d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C0C3121-2813-4AE2-B8A4-4BEDA9566957}"/>
              </a:ext>
            </a:extLst>
          </p:cNvPr>
          <p:cNvSpPr txBox="1"/>
          <p:nvPr/>
        </p:nvSpPr>
        <p:spPr>
          <a:xfrm>
            <a:off x="4667714" y="4868349"/>
            <a:ext cx="809837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8-oxo-dG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2292CF8-0080-4EAE-AA65-0DA9777088EF}"/>
              </a:ext>
            </a:extLst>
          </p:cNvPr>
          <p:cNvSpPr txBox="1"/>
          <p:nvPr/>
        </p:nvSpPr>
        <p:spPr>
          <a:xfrm>
            <a:off x="1895658" y="3003152"/>
            <a:ext cx="290464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I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6636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4D69B4EA-E0BA-405C-8FB1-8216B02759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0638" y="1134946"/>
            <a:ext cx="2914650" cy="1828800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E75EB609-855C-4B49-884A-B7F1A5345B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0638" y="2973686"/>
            <a:ext cx="2914650" cy="182880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D413C53D-7EAE-490F-B80A-3F33DA964B9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0638" y="4812426"/>
            <a:ext cx="2914650" cy="1828800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599B31E1-8F5D-4CED-B510-A5DAE5F2895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0638" y="6651166"/>
            <a:ext cx="2914650" cy="1828800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2B0BD59A-552D-4C10-B5B5-1E3FF419323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55288" y="1134946"/>
            <a:ext cx="2914650" cy="1828800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C59CAB78-24E0-4C87-A46A-63D40EC984F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55288" y="2973686"/>
            <a:ext cx="2914650" cy="182880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C33D4308-4F70-4818-9E6E-13E228531D3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55288" y="4812426"/>
            <a:ext cx="2914650" cy="182880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9AE8866-F512-45CA-9559-D3977ED7BCB3}"/>
              </a:ext>
            </a:extLst>
          </p:cNvPr>
          <p:cNvSpPr txBox="1"/>
          <p:nvPr/>
        </p:nvSpPr>
        <p:spPr>
          <a:xfrm>
            <a:off x="0" y="345060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: Histogram of the quantity of each DNA adduc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CF1812F-95EF-4ADA-825F-33A566936159}"/>
              </a:ext>
            </a:extLst>
          </p:cNvPr>
          <p:cNvSpPr txBox="1"/>
          <p:nvPr/>
        </p:nvSpPr>
        <p:spPr>
          <a:xfrm>
            <a:off x="580316" y="8824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46B78E1-CAF9-4885-8614-C25AEA7452D1}"/>
              </a:ext>
            </a:extLst>
          </p:cNvPr>
          <p:cNvSpPr txBox="1"/>
          <p:nvPr/>
        </p:nvSpPr>
        <p:spPr>
          <a:xfrm>
            <a:off x="530335" y="278902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BC3FA1F-F566-48B6-8BC7-D694B8D94FBD}"/>
              </a:ext>
            </a:extLst>
          </p:cNvPr>
          <p:cNvSpPr txBox="1"/>
          <p:nvPr/>
        </p:nvSpPr>
        <p:spPr>
          <a:xfrm>
            <a:off x="566460" y="449128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3795922-76C3-4ABC-B104-92D9A7655291}"/>
              </a:ext>
            </a:extLst>
          </p:cNvPr>
          <p:cNvSpPr txBox="1"/>
          <p:nvPr/>
        </p:nvSpPr>
        <p:spPr>
          <a:xfrm>
            <a:off x="530335" y="637822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BC25A2C-E1B5-419C-A96D-975DFFAEBE98}"/>
              </a:ext>
            </a:extLst>
          </p:cNvPr>
          <p:cNvSpPr txBox="1"/>
          <p:nvPr/>
        </p:nvSpPr>
        <p:spPr>
          <a:xfrm>
            <a:off x="3444985" y="84747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E29D7B8-2D45-4F48-84CA-BF1711B21CC3}"/>
              </a:ext>
            </a:extLst>
          </p:cNvPr>
          <p:cNvSpPr txBox="1"/>
          <p:nvPr/>
        </p:nvSpPr>
        <p:spPr>
          <a:xfrm>
            <a:off x="3509105" y="2760308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B9C7D3E-3F09-4CF4-B22A-9664150897BC}"/>
              </a:ext>
            </a:extLst>
          </p:cNvPr>
          <p:cNvSpPr txBox="1"/>
          <p:nvPr/>
        </p:nvSpPr>
        <p:spPr>
          <a:xfrm>
            <a:off x="3444985" y="449128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3329896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91</TotalTime>
  <Words>48</Words>
  <Application>Microsoft Office PowerPoint</Application>
  <PresentationFormat>A4 210 x 297 mm</PresentationFormat>
  <Paragraphs>2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雄二 岩下</dc:creator>
  <cp:lastModifiedBy>雄二 岩下</cp:lastModifiedBy>
  <cp:revision>163</cp:revision>
  <dcterms:created xsi:type="dcterms:W3CDTF">2020-10-20T05:53:49Z</dcterms:created>
  <dcterms:modified xsi:type="dcterms:W3CDTF">2021-02-16T06:02:57Z</dcterms:modified>
</cp:coreProperties>
</file>